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5"/>
  </p:normalViewPr>
  <p:slideViewPr>
    <p:cSldViewPr snapToGrid="0" snapToObjects="1">
      <p:cViewPr varScale="1">
        <p:scale>
          <a:sx n="107" d="100"/>
          <a:sy n="107" d="100"/>
        </p:scale>
        <p:origin x="1760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232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39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711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740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045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65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507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713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849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278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156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7695C-8490-AB4B-8F27-13455ECF3F02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C8C6C-B857-ED4D-9930-A0559A8C9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56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grayscale RESAC figures for publication III_Page_10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8121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yscale RESAC figures for publication III_Page_1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1289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yscale RESAC figures for publication III_Page_12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680"/>
          <a:stretch/>
        </p:blipFill>
        <p:spPr>
          <a:xfrm>
            <a:off x="0" y="0"/>
            <a:ext cx="9139125" cy="454824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36914" y="1282535"/>
            <a:ext cx="819397" cy="120032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SP-D</a:t>
            </a:r>
          </a:p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SP-B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21278" y="4548248"/>
            <a:ext cx="69233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Figure S2.  </a:t>
            </a:r>
            <a:r>
              <a:rPr lang="en-US" sz="1200" i="1" dirty="0" smtClean="0">
                <a:latin typeface="Times New Roman" charset="0"/>
                <a:ea typeface="Times New Roman" charset="0"/>
                <a:cs typeface="Times New Roman" charset="0"/>
              </a:rPr>
              <a:t>Immunoblotting at 7 days post instillation: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A)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P-D Immunoblot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B)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P-B Immunoblot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C)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P-D/SP-B ratios; there is considerable variability between individuals within a group, however, the overall trend suggests that nanoparticle treated lungs experience increases in SP-D expression with corresponding decreases in SP-B expression.  The greatest differences compared to the control occur with silver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spher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treatment, though not statistically significant (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CB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= carbon black,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Ag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=silver)</a:t>
            </a:r>
            <a:endParaRPr lang="en-US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6581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05</TotalTime>
  <Words>82</Words>
  <Application>Microsoft Macintosh PowerPoint</Application>
  <PresentationFormat>On-screen Show (4:3)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Calibri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>Rutgers University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Gow</dc:creator>
  <cp:lastModifiedBy>Andrew Gow</cp:lastModifiedBy>
  <cp:revision>12</cp:revision>
  <dcterms:created xsi:type="dcterms:W3CDTF">2016-08-01T22:32:29Z</dcterms:created>
  <dcterms:modified xsi:type="dcterms:W3CDTF">2018-01-08T20:54:20Z</dcterms:modified>
</cp:coreProperties>
</file>